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CED6B0-1109-4BDC-B05B-9B85F4B01D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92CC9-D080-4DB2-B901-19FB25D20C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9613C-182E-40FF-A922-520B49A06B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CB979-007D-4AB5-94CA-2865C9CBBC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D2762-F7D2-4614-9517-6AFF2FE81A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DE4E4-026F-45E7-84DD-0E51DBA06D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85C3B-BBBE-49B9-8F07-E7BCBC120A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70227-7D35-4778-B28D-D899C0AB56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8380D-9FA5-41C6-9DF4-EB5BB5004D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24097-0D1E-47F5-A452-3B1BE8E8C4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40D6A-919F-496E-8544-C73BE9822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DDDB3-CC58-4EEF-A975-780ED7BB92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6964CB-B62C-49BA-82F6-12B1EA336AD4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000160" y="933480"/>
            <a:ext cx="1440000" cy="14400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000160" y="2389320"/>
            <a:ext cx="1440000" cy="1439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2000160" y="3857760"/>
            <a:ext cx="1440000" cy="14396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3468600" y="2389320"/>
            <a:ext cx="1440000" cy="14396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3468600" y="933480"/>
            <a:ext cx="1440000" cy="14400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tretch/>
        </p:blipFill>
        <p:spPr>
          <a:xfrm>
            <a:off x="3468600" y="3857760"/>
            <a:ext cx="1440000" cy="143964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 rot="16200000">
            <a:off x="1368360" y="1451880"/>
            <a:ext cx="98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Vinc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1106640" y="2990880"/>
            <a:ext cx="151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active </a:t>
            </a: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1 integ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1106640" y="4430520"/>
            <a:ext cx="151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7360" y="57240"/>
            <a:ext cx="208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Borisova et al., Fig.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724200" y="679320"/>
            <a:ext cx="90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Vinculin -/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40280" y="679320"/>
            <a:ext cx="99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Vinculin 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001880" y="5546160"/>
            <a:ext cx="501804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Similar distribution of active 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 integrins in vinculin -/- and vinculin WT cell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Vinculin WT and vinculin -/- cells were seeded on Fn coated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ass bottom imaging dishe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next day fixed and stained for vinculin using mouse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human vinculin (hVIN1) antibody, combined with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biotin-SP-conjugated goat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mouse IgG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streptavidin-FITC. In addition, integrin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 in the ligand-bound, active conformation was detected by rat monoclonal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tegrin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1 antibody (clone 9EG7) together with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odamine red conjugated goat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rat IgG antibody. TIRF microscopy was used to assess the distribution of vinculin and active 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 integrins. Bars represent 10 µm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6T07:52:32Z</dcterms:created>
  <dc:creator>Marina Borisova</dc:creator>
  <dc:description/>
  <dc:language>en-US</dc:language>
  <cp:lastModifiedBy>Christof R. Hauck</cp:lastModifiedBy>
  <dcterms:modified xsi:type="dcterms:W3CDTF">2012-07-03T15:20:06Z</dcterms:modified>
  <cp:revision>149</cp:revision>
  <dc:subject/>
  <dc:title>Folie 1</dc:title>
</cp:coreProperties>
</file>